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6006" autoAdjust="0"/>
    <p:restoredTop sz="94660"/>
  </p:normalViewPr>
  <p:slideViewPr>
    <p:cSldViewPr snapToGrid="0">
      <p:cViewPr varScale="1">
        <p:scale>
          <a:sx n="79" d="100"/>
          <a:sy n="79" d="100"/>
        </p:scale>
        <p:origin x="802" y="5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75535C13-FE49-0D8E-9CD3-52454030536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>
            <a:extLst>
              <a:ext uri="{FF2B5EF4-FFF2-40B4-BE49-F238E27FC236}">
                <a16:creationId xmlns:a16="http://schemas.microsoft.com/office/drawing/2014/main" id="{3EF703DE-A713-0508-DD5D-65D6D53BC5E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클릭하여 마스터 부제목 스타일 편집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ADB419FF-4319-F9B7-4018-996618AAF70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45D3F2-7EC2-4FD1-8B64-A36631C961FE}" type="datetimeFigureOut">
              <a:rPr lang="ko-KR" altLang="en-US" smtClean="0"/>
              <a:t>2025-07-17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C87A574F-FDDB-FE67-CA30-120778D1F7E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A5511C8E-BAA0-D5CA-D0D5-9E595DB136E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3AE67E-EA2D-4620-AE1D-18A3D73C4BE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1758982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5AEC5381-E631-8612-1135-242A6ED2C5C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5DB03EAE-0356-DAB8-D54D-1A079FD00D7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C5C82A9F-76DB-A0DA-5AC0-21038F1DAB3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45D3F2-7EC2-4FD1-8B64-A36631C961FE}" type="datetimeFigureOut">
              <a:rPr lang="ko-KR" altLang="en-US" smtClean="0"/>
              <a:t>2025-07-17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CAC8CE00-2207-B372-958E-7CF4925B1FA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379BD869-1131-F07A-E1EC-C7952935C32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3AE67E-EA2D-4620-AE1D-18A3D73C4BE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957480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>
            <a:extLst>
              <a:ext uri="{FF2B5EF4-FFF2-40B4-BE49-F238E27FC236}">
                <a16:creationId xmlns:a16="http://schemas.microsoft.com/office/drawing/2014/main" id="{B36FCB5C-F936-45E7-5D17-7C15A84B9BE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B01D81F1-2D3C-59D4-D266-7FD41B89FAE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A6A221B1-BB34-3D9A-B876-1E223D62A8C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45D3F2-7EC2-4FD1-8B64-A36631C961FE}" type="datetimeFigureOut">
              <a:rPr lang="ko-KR" altLang="en-US" smtClean="0"/>
              <a:t>2025-07-17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B7EDAC34-2697-CCCD-DFCC-02A2BE8C1A6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B000F5F8-1C00-4DDF-980E-2D876DEC2CD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3AE67E-EA2D-4620-AE1D-18A3D73C4BE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7368039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419CB52E-7728-D33E-A5A1-D999F4D5FD2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667FAED2-7258-D413-07EB-18FD261BFD8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5246CCD6-B9AC-2B6E-264C-E2FF648F80B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45D3F2-7EC2-4FD1-8B64-A36631C961FE}" type="datetimeFigureOut">
              <a:rPr lang="ko-KR" altLang="en-US" smtClean="0"/>
              <a:t>2025-07-17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F072B963-0988-6AE8-157E-2E8A8829BA5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96E41861-C30A-DD42-CCCB-05EEEFDE0FA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3AE67E-EA2D-4620-AE1D-18A3D73C4BE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4716021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31B38BB9-BB62-FB85-3CA1-FB2DE927848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E7C21609-EC0E-2B07-D4FA-82F4A38F15E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5D0957FE-F0CB-424B-1BFF-CAA5DDEA660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45D3F2-7EC2-4FD1-8B64-A36631C961FE}" type="datetimeFigureOut">
              <a:rPr lang="ko-KR" altLang="en-US" smtClean="0"/>
              <a:t>2025-07-17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3C9AF8CB-7506-3398-75C8-BD005EB38A8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F6CDAA2F-B9D5-EC55-55FE-0C75D959482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3AE67E-EA2D-4620-AE1D-18A3D73C4BE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8246492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D00FFDF4-7558-D052-7FEB-4D0A26F7AA8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8793FDFC-A4E8-CA4B-59D1-5613747E2AE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A64DA9E3-73CA-1BB3-F6A3-2AB4A75540E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3DA96024-762C-C3B8-10C2-067485AE7C2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45D3F2-7EC2-4FD1-8B64-A36631C961FE}" type="datetimeFigureOut">
              <a:rPr lang="ko-KR" altLang="en-US" smtClean="0"/>
              <a:t>2025-07-17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8B52558C-9A99-76E4-257F-5FF7F677EC6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2D652899-FBBF-C8A4-4185-A5C1AD6A14E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3AE67E-EA2D-4620-AE1D-18A3D73C4BE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6133451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4D6B889F-CB9F-340E-BC73-344C361AD64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0384A584-68D2-2773-0E10-306BBF2375E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5303F48A-40FA-1647-38A2-53331218D2E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5" name="텍스트 개체 틀 4">
            <a:extLst>
              <a:ext uri="{FF2B5EF4-FFF2-40B4-BE49-F238E27FC236}">
                <a16:creationId xmlns:a16="http://schemas.microsoft.com/office/drawing/2014/main" id="{DD8606CE-BC66-DC52-8579-EF4323DB3AC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6" name="내용 개체 틀 5">
            <a:extLst>
              <a:ext uri="{FF2B5EF4-FFF2-40B4-BE49-F238E27FC236}">
                <a16:creationId xmlns:a16="http://schemas.microsoft.com/office/drawing/2014/main" id="{D5C38827-B75F-7BFD-F4C1-E5E8EDF51F0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7" name="날짜 개체 틀 6">
            <a:extLst>
              <a:ext uri="{FF2B5EF4-FFF2-40B4-BE49-F238E27FC236}">
                <a16:creationId xmlns:a16="http://schemas.microsoft.com/office/drawing/2014/main" id="{374FCB2B-C325-791E-26C0-023B53B6B3D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45D3F2-7EC2-4FD1-8B64-A36631C961FE}" type="datetimeFigureOut">
              <a:rPr lang="ko-KR" altLang="en-US" smtClean="0"/>
              <a:t>2025-07-17</a:t>
            </a:fld>
            <a:endParaRPr lang="ko-KR" altLang="en-US"/>
          </a:p>
        </p:txBody>
      </p:sp>
      <p:sp>
        <p:nvSpPr>
          <p:cNvPr id="8" name="바닥글 개체 틀 7">
            <a:extLst>
              <a:ext uri="{FF2B5EF4-FFF2-40B4-BE49-F238E27FC236}">
                <a16:creationId xmlns:a16="http://schemas.microsoft.com/office/drawing/2014/main" id="{137D0452-E030-7401-D606-6FB2381E907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>
            <a:extLst>
              <a:ext uri="{FF2B5EF4-FFF2-40B4-BE49-F238E27FC236}">
                <a16:creationId xmlns:a16="http://schemas.microsoft.com/office/drawing/2014/main" id="{321B3D57-B69E-5E43-1DCB-8CBA9FC5769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3AE67E-EA2D-4620-AE1D-18A3D73C4BE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999111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1F11936F-6129-2792-A2A8-29F42D23955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>
            <a:extLst>
              <a:ext uri="{FF2B5EF4-FFF2-40B4-BE49-F238E27FC236}">
                <a16:creationId xmlns:a16="http://schemas.microsoft.com/office/drawing/2014/main" id="{8D89A5C4-E4FB-0807-144F-0E04AE3E81A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45D3F2-7EC2-4FD1-8B64-A36631C961FE}" type="datetimeFigureOut">
              <a:rPr lang="ko-KR" altLang="en-US" smtClean="0"/>
              <a:t>2025-07-17</a:t>
            </a:fld>
            <a:endParaRPr lang="ko-KR" altLang="en-US"/>
          </a:p>
        </p:txBody>
      </p:sp>
      <p:sp>
        <p:nvSpPr>
          <p:cNvPr id="4" name="바닥글 개체 틀 3">
            <a:extLst>
              <a:ext uri="{FF2B5EF4-FFF2-40B4-BE49-F238E27FC236}">
                <a16:creationId xmlns:a16="http://schemas.microsoft.com/office/drawing/2014/main" id="{5DE0974D-1094-23BB-5DBA-F25227E9FC4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>
            <a:extLst>
              <a:ext uri="{FF2B5EF4-FFF2-40B4-BE49-F238E27FC236}">
                <a16:creationId xmlns:a16="http://schemas.microsoft.com/office/drawing/2014/main" id="{7B67B685-46E9-B372-1D54-6E294CB01D8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3AE67E-EA2D-4620-AE1D-18A3D73C4BE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2557085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>
            <a:extLst>
              <a:ext uri="{FF2B5EF4-FFF2-40B4-BE49-F238E27FC236}">
                <a16:creationId xmlns:a16="http://schemas.microsoft.com/office/drawing/2014/main" id="{FB98D668-4F5F-71A4-D2F9-2FB2BBFC3A5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45D3F2-7EC2-4FD1-8B64-A36631C961FE}" type="datetimeFigureOut">
              <a:rPr lang="ko-KR" altLang="en-US" smtClean="0"/>
              <a:t>2025-07-17</a:t>
            </a:fld>
            <a:endParaRPr lang="ko-KR" altLang="en-US"/>
          </a:p>
        </p:txBody>
      </p:sp>
      <p:sp>
        <p:nvSpPr>
          <p:cNvPr id="3" name="바닥글 개체 틀 2">
            <a:extLst>
              <a:ext uri="{FF2B5EF4-FFF2-40B4-BE49-F238E27FC236}">
                <a16:creationId xmlns:a16="http://schemas.microsoft.com/office/drawing/2014/main" id="{4A17819F-7F49-5123-1FA6-40FCBC54DB7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>
            <a:extLst>
              <a:ext uri="{FF2B5EF4-FFF2-40B4-BE49-F238E27FC236}">
                <a16:creationId xmlns:a16="http://schemas.microsoft.com/office/drawing/2014/main" id="{2292AF00-47AF-FBCC-1A17-6E6B24D80E3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3AE67E-EA2D-4620-AE1D-18A3D73C4BE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20022584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F8375232-E091-47F9-19FA-702B5FE9E24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2399D940-742E-A061-A5C5-DE5CA588F18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F3698431-A448-0A1B-87CE-2674B9487E5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0DAB7DE6-8BC6-013B-862C-B7998ED8F88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45D3F2-7EC2-4FD1-8B64-A36631C961FE}" type="datetimeFigureOut">
              <a:rPr lang="ko-KR" altLang="en-US" smtClean="0"/>
              <a:t>2025-07-17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CB296BCC-CAB2-50EC-C91D-C984AA0745C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BBF0867F-E5FE-CDD6-CC93-E88C956CEA1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3AE67E-EA2D-4620-AE1D-18A3D73C4BE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5576468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8707BF8A-15C2-DC37-9BC6-3F106E2E61E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>
            <a:extLst>
              <a:ext uri="{FF2B5EF4-FFF2-40B4-BE49-F238E27FC236}">
                <a16:creationId xmlns:a16="http://schemas.microsoft.com/office/drawing/2014/main" id="{98B2E275-D7EC-BBCE-22E7-8D4A29593D4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BC8867B0-CDED-7216-8965-965E1446A07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3FE4D31C-EF2A-E0F8-6C58-C1F2558826B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45D3F2-7EC2-4FD1-8B64-A36631C961FE}" type="datetimeFigureOut">
              <a:rPr lang="ko-KR" altLang="en-US" smtClean="0"/>
              <a:t>2025-07-17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B4E23482-8473-264F-388E-031039DAED4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14D71AC9-EC3F-40FF-DB92-AA9B81279AC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3AE67E-EA2D-4620-AE1D-18A3D73C4BE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6686137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>
            <a:extLst>
              <a:ext uri="{FF2B5EF4-FFF2-40B4-BE49-F238E27FC236}">
                <a16:creationId xmlns:a16="http://schemas.microsoft.com/office/drawing/2014/main" id="{9518349F-AA62-479C-F8F7-EC819259A4F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43BA7232-CA1A-27A4-333C-C9313700692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86418CCB-3CC8-7EF5-5912-DCE0771844E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E45D3F2-7EC2-4FD1-8B64-A36631C961FE}" type="datetimeFigureOut">
              <a:rPr lang="ko-KR" altLang="en-US" smtClean="0"/>
              <a:t>2025-07-17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7B0D554F-4869-3ADE-931D-3909EAB9F42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518095ED-C9EC-93E7-A8D3-6A12D2F6C4C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B3AE67E-EA2D-4620-AE1D-18A3D73C4BE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8392670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07C337FF-90B4-90A3-8F6A-A1A2CDED1E95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>
            <a:extLst>
              <a:ext uri="{FF2B5EF4-FFF2-40B4-BE49-F238E27FC236}">
                <a16:creationId xmlns:a16="http://schemas.microsoft.com/office/drawing/2014/main" id="{AF965246-C2AF-743E-75FA-E89B05B7F5AA}"/>
              </a:ext>
            </a:extLst>
          </p:cNvPr>
          <p:cNvSpPr txBox="1"/>
          <p:nvPr/>
        </p:nvSpPr>
        <p:spPr>
          <a:xfrm>
            <a:off x="7809782" y="5657673"/>
            <a:ext cx="4180936" cy="120032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1200" b="1" dirty="0">
                <a:latin typeface="Times New Roman Uni" panose="02020603050405020304" pitchFamily="18" charset="-127"/>
                <a:ea typeface="Times New Roman Uni" panose="02020603050405020304" pitchFamily="18" charset="-127"/>
                <a:cs typeface="Times New Roman Uni" panose="02020603050405020304" pitchFamily="18" charset="-127"/>
              </a:rPr>
              <a:t>Supplementary </a:t>
            </a:r>
            <a:r>
              <a:rPr lang="en-US" altLang="ko-KR" sz="1200" b="1">
                <a:latin typeface="Times New Roman Uni" panose="02020603050405020304" pitchFamily="18" charset="-127"/>
                <a:ea typeface="Times New Roman Uni" panose="02020603050405020304" pitchFamily="18" charset="-127"/>
                <a:cs typeface="Times New Roman Uni" panose="02020603050405020304" pitchFamily="18" charset="-127"/>
              </a:rPr>
              <a:t>Figure S1</a:t>
            </a:r>
            <a:r>
              <a:rPr lang="en-US" altLang="ko-KR" sz="1200" b="1" dirty="0">
                <a:latin typeface="Times New Roman Uni" panose="02020603050405020304" pitchFamily="18" charset="-127"/>
                <a:ea typeface="Times New Roman Uni" panose="02020603050405020304" pitchFamily="18" charset="-127"/>
                <a:cs typeface="Times New Roman Uni" panose="02020603050405020304" pitchFamily="18" charset="-127"/>
              </a:rPr>
              <a:t>. Association of Thyroid Cancer Risk with a 1 SD Increase in Bilirubin Subtypes, ALBI, and PALBI in Men and Women Aged Below 50 Years</a:t>
            </a:r>
          </a:p>
          <a:p>
            <a:r>
              <a:rPr lang="en-US" altLang="ko-KR" sz="1200" dirty="0">
                <a:latin typeface="Times New Roman Uni" panose="02020603050405020304" pitchFamily="18" charset="-127"/>
                <a:ea typeface="Times New Roman Uni" panose="02020603050405020304" pitchFamily="18" charset="-127"/>
                <a:cs typeface="Times New Roman Uni" panose="02020603050405020304" pitchFamily="18" charset="-127"/>
              </a:rPr>
              <a:t>Note: Error bars represent 95% confidence intervals. *p &lt; 0.05.</a:t>
            </a:r>
            <a:endParaRPr lang="ko-KR" altLang="en-US" sz="1200" dirty="0">
              <a:latin typeface="Times New Roman Uni" panose="02020603050405020304" pitchFamily="18" charset="-127"/>
              <a:ea typeface="Times New Roman Uni" panose="02020603050405020304" pitchFamily="18" charset="-127"/>
              <a:cs typeface="Times New Roman Uni" panose="02020603050405020304" pitchFamily="18" charset="-127"/>
            </a:endParaRPr>
          </a:p>
        </p:txBody>
      </p:sp>
      <p:pic>
        <p:nvPicPr>
          <p:cNvPr id="3" name="그림 2">
            <a:extLst>
              <a:ext uri="{FF2B5EF4-FFF2-40B4-BE49-F238E27FC236}">
                <a16:creationId xmlns:a16="http://schemas.microsoft.com/office/drawing/2014/main" id="{94771921-8759-4C66-9479-31A8F404105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1282" y="152365"/>
            <a:ext cx="7399263" cy="664812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0869644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5</Words>
  <Application>Microsoft Office PowerPoint</Application>
  <PresentationFormat>Widescreen</PresentationFormat>
  <Paragraphs>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맑은 고딕</vt:lpstr>
      <vt:lpstr>Times New Roman Uni</vt:lpstr>
      <vt:lpstr>Arial</vt:lpstr>
      <vt:lpstr>Office 테마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종원 신</dc:creator>
  <cp:lastModifiedBy>MDPI</cp:lastModifiedBy>
  <cp:revision>3</cp:revision>
  <dcterms:created xsi:type="dcterms:W3CDTF">2025-07-04T13:43:09Z</dcterms:created>
  <dcterms:modified xsi:type="dcterms:W3CDTF">2025-07-17T03:31:55Z</dcterms:modified>
</cp:coreProperties>
</file>